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78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3AAF18-725C-C1A2-08A4-B9CE69B1E3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B1F357A-A655-7822-5638-45B117E89D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097715-433B-C778-E35F-E4C391307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5EF22B-DDD9-4308-1A8B-F81066EAE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A0732A-A9AA-2200-3C5E-C3408E4AA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7705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53496F-6283-CAD4-D907-B53653FF5A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9D7B4BA-97F9-FF75-7FB0-4F5374571B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E5F684-1CE5-EA57-6F40-2414AAD88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7F91D9-195A-3E22-1C24-6722EB18C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DE53A-7C50-9A5E-FF8B-92D653418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1010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A18FD9D-A55C-B977-56A7-73C686F54C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9992BA1-998A-00DC-9560-3E52C4ABB9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4FFC7-FBE3-2E75-87EA-99DDA3431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D66CEC-F0EB-D654-0EDE-52F2DD247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9EA758-4607-2107-7615-836541099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397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9393D0-514D-2E6B-1F5C-8FA0FB7C16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7DA0D46-891D-85E9-290B-A497547B3B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CB76CC-3A22-3D79-D7FE-CF309247C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7AAC7E-67FA-C186-C876-D9BFF3E1F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343880-4203-7887-993C-0FAB64365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9916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F7ADA7-35FA-EC53-1C7A-1DC3760165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094526-D90B-B20F-F9C3-FF49015786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F3E0F8F-42E0-5962-34E9-82CC19FF7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940BEC6-BD65-FEFB-E69C-39E4AC52C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4D84E6E-1483-9802-E29F-988F3904A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6945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39BE8F-ED46-25EF-14A9-A6C20DA574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5711DB2-9D39-07CD-51F6-79EBC01F40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A59FE46-025D-1B0B-7A2D-89A3385B75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31973EA-EDC5-63A0-E695-2537F9C61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7A93F9-9DEE-9B4C-37AB-197E7EB79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8358CAB-4BE0-9427-CD90-43DA95224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3323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16A66A-8BC6-52E6-CC7C-92FA4200B7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AC3C33E-8090-3125-D27B-3C86B40FC6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4EDCC8D-FDDC-6B02-A0EB-0AAF72ED97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B1BC2DB-1339-C41E-F396-C4EFFC9061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A9A6F21-BE7C-354B-C6F6-8D81C45F02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CD187DE-348F-2DCB-5E83-8DD29FEFA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5FA2D5B-44AF-C125-4CDF-DEB1DC17E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7EAF35-5998-D25A-77D0-EE40AE7E6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1511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EF9937-558E-D7D9-F6D5-C6AE729DD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649CD73-3604-68B5-602B-F38F6A50A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D1602C9-93A9-ECDB-6742-A9AA34C9CD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8AE013F-9A82-E94D-96DA-D8802A63A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6862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A29EB8D-48EC-2D24-49E8-83B50EB5B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52AAB7E-4D83-7FA9-4EC4-188CD2258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96B30AD-B960-0D17-E791-52854E5A4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0106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2DDF52-8094-CDEE-654A-71CF5BF7A3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4A321E7-DE06-E8A0-85CC-9BA78CF4B0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332F98E-CE39-2803-8B17-A8BDAE0B41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ED7AE9B-F9A8-0F64-2AD5-070260A49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A77B976-7682-6727-88A4-3231C49AC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B236D0E-6EB1-1BD6-B01A-9EF0D55CE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429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0960A4-C25E-D030-FB0A-394F6842A3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558039C-4581-C2C1-45F4-520FBBEAE5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45ED9B3-930C-16BA-8EA2-9046B7EA05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EF709DB-ADA4-D917-3DFE-C8E28B486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BD4B92-EEEF-E31E-2A18-2D770CA36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7FD8D4-83BC-BAE6-4798-35E9AFD26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5842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789B029-2D9B-D3EC-B599-00AB446C15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BC7A864-49EA-A116-CC04-442E2DF0B7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A81A65-445F-447A-AF79-29C6AFBBBA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09FF9-D0BE-45EC-9A19-03FC5D73650F}" type="datetimeFigureOut">
              <a:rPr lang="zh-CN" altLang="en-US" smtClean="0"/>
              <a:t>2024-1-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0CF799-9882-A2A4-C4D3-C3F4A0367F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D377F2-C2E0-5E58-49F7-19C907D6E7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6C4DA-AEF6-421C-A3F0-5F7BE34618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8790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0A9BFDC6-7ACC-D214-24B4-969D78F59218}"/>
              </a:ext>
            </a:extLst>
          </p:cNvPr>
          <p:cNvCxnSpPr>
            <a:cxnSpLocks/>
          </p:cNvCxnSpPr>
          <p:nvPr/>
        </p:nvCxnSpPr>
        <p:spPr>
          <a:xfrm flipV="1">
            <a:off x="1012723" y="3429000"/>
            <a:ext cx="10707329" cy="319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椭圆 7">
            <a:extLst>
              <a:ext uri="{FF2B5EF4-FFF2-40B4-BE49-F238E27FC236}">
                <a16:creationId xmlns:a16="http://schemas.microsoft.com/office/drawing/2014/main" id="{C77B7C59-899A-BD48-9E83-D442C4E29CD7}"/>
              </a:ext>
            </a:extLst>
          </p:cNvPr>
          <p:cNvSpPr/>
          <p:nvPr/>
        </p:nvSpPr>
        <p:spPr>
          <a:xfrm>
            <a:off x="1564559" y="3379846"/>
            <a:ext cx="98323" cy="78656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椭圆 8">
            <a:extLst>
              <a:ext uri="{FF2B5EF4-FFF2-40B4-BE49-F238E27FC236}">
                <a16:creationId xmlns:a16="http://schemas.microsoft.com/office/drawing/2014/main" id="{F4349C8D-908D-F095-6FE2-9C39A0EBA99E}"/>
              </a:ext>
            </a:extLst>
          </p:cNvPr>
          <p:cNvSpPr/>
          <p:nvPr/>
        </p:nvSpPr>
        <p:spPr>
          <a:xfrm>
            <a:off x="9119416" y="3350344"/>
            <a:ext cx="98323" cy="78656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椭圆 9">
            <a:extLst>
              <a:ext uri="{FF2B5EF4-FFF2-40B4-BE49-F238E27FC236}">
                <a16:creationId xmlns:a16="http://schemas.microsoft.com/office/drawing/2014/main" id="{362A05D2-4156-3B8F-9485-3ED1784141D4}"/>
              </a:ext>
            </a:extLst>
          </p:cNvPr>
          <p:cNvSpPr/>
          <p:nvPr/>
        </p:nvSpPr>
        <p:spPr>
          <a:xfrm>
            <a:off x="7350841" y="3366322"/>
            <a:ext cx="98323" cy="78656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椭圆 10">
            <a:extLst>
              <a:ext uri="{FF2B5EF4-FFF2-40B4-BE49-F238E27FC236}">
                <a16:creationId xmlns:a16="http://schemas.microsoft.com/office/drawing/2014/main" id="{AFB6DCBE-CCE1-6488-0C0E-81212988CF9D}"/>
              </a:ext>
            </a:extLst>
          </p:cNvPr>
          <p:cNvSpPr/>
          <p:nvPr/>
        </p:nvSpPr>
        <p:spPr>
          <a:xfrm>
            <a:off x="5533103" y="3379846"/>
            <a:ext cx="98323" cy="78656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椭圆 11">
            <a:extLst>
              <a:ext uri="{FF2B5EF4-FFF2-40B4-BE49-F238E27FC236}">
                <a16:creationId xmlns:a16="http://schemas.microsoft.com/office/drawing/2014/main" id="{08703EE5-0EB8-DC8F-9AC9-44CC759228B0}"/>
              </a:ext>
            </a:extLst>
          </p:cNvPr>
          <p:cNvSpPr/>
          <p:nvPr/>
        </p:nvSpPr>
        <p:spPr>
          <a:xfrm>
            <a:off x="3431458" y="3389672"/>
            <a:ext cx="98323" cy="78656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8262033-45F0-0889-086F-6E93B0155722}"/>
              </a:ext>
            </a:extLst>
          </p:cNvPr>
          <p:cNvSpPr txBox="1"/>
          <p:nvPr/>
        </p:nvSpPr>
        <p:spPr>
          <a:xfrm>
            <a:off x="992177" y="3571568"/>
            <a:ext cx="1112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2:00 pm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2BAD1FA-57DC-21CB-E13F-6AA53E7FD054}"/>
              </a:ext>
            </a:extLst>
          </p:cNvPr>
          <p:cNvSpPr txBox="1"/>
          <p:nvPr/>
        </p:nvSpPr>
        <p:spPr>
          <a:xfrm>
            <a:off x="1012723" y="2694793"/>
            <a:ext cx="14967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arted bowel preparation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2EB3D53-E58C-A98E-D0E6-36D75EBA91F8}"/>
              </a:ext>
            </a:extLst>
          </p:cNvPr>
          <p:cNvSpPr txBox="1"/>
          <p:nvPr/>
        </p:nvSpPr>
        <p:spPr>
          <a:xfrm>
            <a:off x="2933033" y="3571568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01:00 am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C7CA12D-0742-8234-0633-EC0B963E4FE5}"/>
              </a:ext>
            </a:extLst>
          </p:cNvPr>
          <p:cNvSpPr txBox="1"/>
          <p:nvPr/>
        </p:nvSpPr>
        <p:spPr>
          <a:xfrm>
            <a:off x="2677539" y="2363102"/>
            <a:ext cx="20647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F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nished consuming 250 mL of mannitol and 2 L of water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1F6D3FA-AD39-C316-1771-E46B7017682D}"/>
              </a:ext>
            </a:extLst>
          </p:cNvPr>
          <p:cNvSpPr txBox="1"/>
          <p:nvPr/>
        </p:nvSpPr>
        <p:spPr>
          <a:xfrm>
            <a:off x="4977940" y="3571568"/>
            <a:ext cx="1262735" cy="3810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01:30 am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828334B-DD18-2DFC-6C73-F2E31BB12DD2}"/>
              </a:ext>
            </a:extLst>
          </p:cNvPr>
          <p:cNvSpPr txBox="1"/>
          <p:nvPr/>
        </p:nvSpPr>
        <p:spPr>
          <a:xfrm>
            <a:off x="4910339" y="2380314"/>
            <a:ext cx="16862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Onset of nausea, vomiting and other symptoms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27A10CF-515F-5E8F-0BDC-4130080C3122}"/>
              </a:ext>
            </a:extLst>
          </p:cNvPr>
          <p:cNvSpPr txBox="1"/>
          <p:nvPr/>
        </p:nvSpPr>
        <p:spPr>
          <a:xfrm>
            <a:off x="6852416" y="3589397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08:22 am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ACD981E-54ED-797E-041E-EBD108AA9EA6}"/>
              </a:ext>
            </a:extLst>
          </p:cNvPr>
          <p:cNvSpPr txBox="1"/>
          <p:nvPr/>
        </p:nvSpPr>
        <p:spPr>
          <a:xfrm>
            <a:off x="6764598" y="2413781"/>
            <a:ext cx="16862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hest CT shows a left pleural effusion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497DBE3-D52B-E7E8-9289-3EE5C02E9A85}"/>
              </a:ext>
            </a:extLst>
          </p:cNvPr>
          <p:cNvSpPr txBox="1"/>
          <p:nvPr/>
        </p:nvSpPr>
        <p:spPr>
          <a:xfrm>
            <a:off x="8620992" y="3571568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:30 am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5090EB3-C50C-EB8C-D6AE-E4630DBBB5B4}"/>
              </a:ext>
            </a:extLst>
          </p:cNvPr>
          <p:cNvSpPr txBox="1"/>
          <p:nvPr/>
        </p:nvSpPr>
        <p:spPr>
          <a:xfrm>
            <a:off x="8512274" y="2654228"/>
            <a:ext cx="13126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U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derwent gastroscopy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D7FB120-2151-75DC-82DE-54A709E5831E}"/>
              </a:ext>
            </a:extLst>
          </p:cNvPr>
          <p:cNvSpPr txBox="1"/>
          <p:nvPr/>
        </p:nvSpPr>
        <p:spPr>
          <a:xfrm>
            <a:off x="10104651" y="3586312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:48 am</a:t>
            </a:r>
            <a:endParaRPr lang="zh-CN" altLang="en-US" dirty="0"/>
          </a:p>
        </p:txBody>
      </p:sp>
      <p:sp>
        <p:nvSpPr>
          <p:cNvPr id="29" name="椭圆 28">
            <a:extLst>
              <a:ext uri="{FF2B5EF4-FFF2-40B4-BE49-F238E27FC236}">
                <a16:creationId xmlns:a16="http://schemas.microsoft.com/office/drawing/2014/main" id="{199B7D73-592E-32B9-4AB0-4478C8E99D1C}"/>
              </a:ext>
            </a:extLst>
          </p:cNvPr>
          <p:cNvSpPr/>
          <p:nvPr/>
        </p:nvSpPr>
        <p:spPr>
          <a:xfrm>
            <a:off x="10603075" y="3389672"/>
            <a:ext cx="98323" cy="78656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F18DD4C-6165-19AC-5AFD-1BE3CB4FCFE2}"/>
              </a:ext>
            </a:extLst>
          </p:cNvPr>
          <p:cNvSpPr txBox="1"/>
          <p:nvPr/>
        </p:nvSpPr>
        <p:spPr>
          <a:xfrm>
            <a:off x="10054865" y="2136782"/>
            <a:ext cx="199183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Suturing of the split was accomplished using titanium clip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64046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52</Words>
  <Application>Microsoft Office PowerPoint</Application>
  <PresentationFormat>宽屏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ruoyu gao</dc:creator>
  <cp:lastModifiedBy>ruoyu gao</cp:lastModifiedBy>
  <cp:revision>1</cp:revision>
  <dcterms:created xsi:type="dcterms:W3CDTF">2024-01-21T14:23:42Z</dcterms:created>
  <dcterms:modified xsi:type="dcterms:W3CDTF">2024-01-21T15:49:49Z</dcterms:modified>
</cp:coreProperties>
</file>